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2" r:id="rId2"/>
    <p:sldId id="263" r:id="rId3"/>
    <p:sldId id="275" r:id="rId4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E605C"/>
    <a:srgbClr val="FFC1C1"/>
    <a:srgbClr val="FFBBBB"/>
    <a:srgbClr val="989AFE"/>
    <a:srgbClr val="555DFD"/>
    <a:srgbClr val="676EFD"/>
    <a:srgbClr val="8FAAFF"/>
    <a:srgbClr val="B9B9FF"/>
    <a:srgbClr val="66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 varScale="1">
        <p:scale>
          <a:sx n="58" d="100"/>
          <a:sy n="58" d="100"/>
        </p:scale>
        <p:origin x="1932" y="5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A4FBD8-8D99-4DB0-9D47-20BFD4AD0A58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876667-0641-428B-8C2B-5F42289BF7A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97508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6656B7-BF29-4C54-BA0C-7F045BB646FA}" type="datetimeFigureOut">
              <a:rPr lang="de-DE" smtClean="0"/>
              <a:pPr/>
              <a:t>26.0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53849E-6610-47E3-A920-9748DBFA0248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3"/>
          <p:cNvSpPr/>
          <p:nvPr/>
        </p:nvSpPr>
        <p:spPr>
          <a:xfrm>
            <a:off x="1591198" y="834768"/>
            <a:ext cx="1466335" cy="1449859"/>
          </a:xfrm>
          <a:prstGeom prst="ellipse">
            <a:avLst/>
          </a:prstGeom>
          <a:solidFill>
            <a:schemeClr val="accent6">
              <a:alpha val="30980"/>
            </a:schemeClr>
          </a:solidFill>
          <a:ln w="38100"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" name="Oval 4"/>
          <p:cNvSpPr/>
          <p:nvPr/>
        </p:nvSpPr>
        <p:spPr>
          <a:xfrm rot="637518">
            <a:off x="2553054" y="733608"/>
            <a:ext cx="1715380" cy="1675309"/>
          </a:xfrm>
          <a:prstGeom prst="ellipse">
            <a:avLst/>
          </a:prstGeom>
          <a:solidFill>
            <a:srgbClr val="FFC000">
              <a:alpha val="32157"/>
            </a:srgbClr>
          </a:solidFill>
          <a:ln w="38100"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endParaRPr lang="de-DE" dirty="0"/>
          </a:p>
        </p:txBody>
      </p:sp>
      <p:sp>
        <p:nvSpPr>
          <p:cNvPr id="4" name="TextBox 6"/>
          <p:cNvSpPr txBox="1"/>
          <p:nvPr/>
        </p:nvSpPr>
        <p:spPr>
          <a:xfrm>
            <a:off x="2649929" y="1388892"/>
            <a:ext cx="5416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Arial" pitchFamily="34" charset="0"/>
                <a:cs typeface="Arial" pitchFamily="34" charset="0"/>
              </a:rPr>
              <a:t>5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7"/>
          <p:cNvSpPr txBox="1"/>
          <p:nvPr/>
        </p:nvSpPr>
        <p:spPr>
          <a:xfrm>
            <a:off x="3407488" y="1388892"/>
            <a:ext cx="5416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Arial" pitchFamily="34" charset="0"/>
                <a:cs typeface="Arial" pitchFamily="34" charset="0"/>
              </a:rPr>
              <a:t>292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8"/>
          <p:cNvSpPr txBox="1"/>
          <p:nvPr/>
        </p:nvSpPr>
        <p:spPr>
          <a:xfrm>
            <a:off x="1824926" y="1388892"/>
            <a:ext cx="5416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Arial" pitchFamily="34" charset="0"/>
                <a:cs typeface="Arial" pitchFamily="34" charset="0"/>
              </a:rPr>
              <a:t>147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9"/>
          <p:cNvSpPr txBox="1"/>
          <p:nvPr/>
        </p:nvSpPr>
        <p:spPr>
          <a:xfrm>
            <a:off x="430973" y="944144"/>
            <a:ext cx="116946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Genes under retrograde biogenic control 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  <a:p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ctangle 10"/>
          <p:cNvSpPr/>
          <p:nvPr/>
        </p:nvSpPr>
        <p:spPr>
          <a:xfrm>
            <a:off x="4346861" y="940019"/>
            <a:ext cx="193201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Direct HY5 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target genes </a:t>
            </a:r>
          </a:p>
          <a:p>
            <a:r>
              <a:rPr lang="de-DE" sz="1200" i="1" dirty="0" err="1" smtClean="0"/>
              <a:t>From</a:t>
            </a:r>
            <a:r>
              <a:rPr lang="de-DE" sz="1200" i="1" dirty="0" smtClean="0"/>
              <a:t> </a:t>
            </a:r>
            <a:r>
              <a:rPr lang="de-DE" sz="1200" i="1" dirty="0" err="1" smtClean="0"/>
              <a:t>Burko</a:t>
            </a:r>
            <a:r>
              <a:rPr lang="de-DE" sz="1200" i="1" dirty="0" smtClean="0"/>
              <a:t> et al. 2020 Plant </a:t>
            </a:r>
            <a:r>
              <a:rPr lang="de-DE" sz="1200" i="1" dirty="0" err="1" smtClean="0"/>
              <a:t>Cell</a:t>
            </a:r>
            <a:endParaRPr lang="de-DE" sz="1200" dirty="0"/>
          </a:p>
        </p:txBody>
      </p:sp>
      <p:graphicFrame>
        <p:nvGraphicFramePr>
          <p:cNvPr id="9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0481058"/>
              </p:ext>
            </p:extLst>
          </p:nvPr>
        </p:nvGraphicFramePr>
        <p:xfrm>
          <a:off x="541019" y="2795389"/>
          <a:ext cx="5178440" cy="2453682"/>
        </p:xfrm>
        <a:graphic>
          <a:graphicData uri="http://schemas.openxmlformats.org/drawingml/2006/table">
            <a:tbl>
              <a:tblPr/>
              <a:tblGrid>
                <a:gridCol w="84851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15815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3712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6151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2408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4904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293207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de-DE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RB- </a:t>
                      </a:r>
                      <a:r>
                        <a:rPr lang="de-DE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nd</a:t>
                      </a:r>
                      <a:r>
                        <a:rPr lang="de-DE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HY5- </a:t>
                      </a:r>
                      <a:r>
                        <a:rPr lang="de-DE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ontrolled</a:t>
                      </a:r>
                      <a:r>
                        <a:rPr lang="de-DE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enes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0818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Locu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Descrip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WT 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LIN 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vs. W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WT NF vs. W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ap7-1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vs. W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WT light vs. WT dar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85774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1g033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ATBE2/ ISA2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isoamylas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de-DE" sz="9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7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A1A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4949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0.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8B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787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338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1g4457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NPQ4 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non-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hotochemical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quenching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;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sbS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) 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E7E6E6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3.4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E7E6E6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3.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0.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C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25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5g6584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hioredoxin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superfamily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E7E6E6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2.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E7E6E6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05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0.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B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43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5g1723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SY (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hytoene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synthase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)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E7E6E6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2.0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E7E6E6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8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414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0.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B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A5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83536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5g070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MPH1 (Maintenance of PSII under high light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)</a:t>
                      </a:r>
                      <a:r>
                        <a:rPr lang="en-US" sz="900" b="0" i="0" u="none" strike="noStrike" baseline="30000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E7E6E6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1.3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5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E7E6E6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2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0.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696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sp>
        <p:nvSpPr>
          <p:cNvPr id="10" name="Rechteck 9"/>
          <p:cNvSpPr/>
          <p:nvPr/>
        </p:nvSpPr>
        <p:spPr>
          <a:xfrm>
            <a:off x="419100" y="5510791"/>
            <a:ext cx="595122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l Figure 1. Comparison of RB-affected genes with direct HY5 target genes. A)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Venn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diagramm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depicting the overlap of the RB core module with direct HY5 target genes.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B)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Identities of the five genes identified in both data sets. Arrangement of micro-array based expression data is as given in Fig. 2. All data represent log2-fold expression changes. Gene identities (Locus) and respective encoded proteins (Description) are given in columns to the left. Genes encoding proteins with predicted or proven plastid localization are high-lighted in light-green.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440122" y="414066"/>
            <a:ext cx="327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itchFamily="34" charset="0"/>
                <a:cs typeface="Arial" pitchFamily="34" charset="0"/>
              </a:rPr>
              <a:t>A </a:t>
            </a:r>
            <a:endParaRPr lang="de-DE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39779" y="2417438"/>
            <a:ext cx="327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itchFamily="34" charset="0"/>
                <a:cs typeface="Arial" pitchFamily="34" charset="0"/>
              </a:rPr>
              <a:t>B </a:t>
            </a:r>
            <a:endParaRPr lang="de-DE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6277526"/>
              </p:ext>
            </p:extLst>
          </p:nvPr>
        </p:nvGraphicFramePr>
        <p:xfrm>
          <a:off x="715616" y="530951"/>
          <a:ext cx="4937761" cy="6837761"/>
        </p:xfrm>
        <a:graphic>
          <a:graphicData uri="http://schemas.openxmlformats.org/drawingml/2006/table">
            <a:tbl>
              <a:tblPr/>
              <a:tblGrid>
                <a:gridCol w="826937"/>
                <a:gridCol w="2018650"/>
                <a:gridCol w="501914"/>
                <a:gridCol w="492980"/>
                <a:gridCol w="508884"/>
                <a:gridCol w="588396"/>
              </a:tblGrid>
              <a:tr h="208189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de-DE" sz="1200" b="1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iscellaneous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12460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ocus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escription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T 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IN 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vs. WT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T NF vs. WT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p7-1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vs. WT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T light vs. WT dark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863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1G2150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Unknown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5.45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4.62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02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7C7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4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85320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2G2551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Transmembran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unknown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4.48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3.98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3.17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.56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304697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5G2301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AM1 (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ethylthioalkylmalat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ynthase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1)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2.48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5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6C6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79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B1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88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80234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5G4458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Unknown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2.3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3.02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40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C4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56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314851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3G5347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3-bisphosphoglycerate-independent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hosphoglycerat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utas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2.07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59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34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0.62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0B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5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979"/>
                    </a:solidFill>
                  </a:tcPr>
                </a:tc>
              </a:tr>
              <a:tr h="213248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1G4740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EP3 (Fe-uptake-inducing peptide3)</a:t>
                      </a:r>
                      <a:r>
                        <a:rPr lang="de-DE" sz="900" b="0" i="0" u="none" strike="noStrike" baseline="30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99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3.1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11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17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49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242"/>
                    </a:solidFill>
                  </a:tcPr>
                </a:tc>
              </a:tr>
              <a:tr h="180225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3G50685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Unknown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98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30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2.77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0.79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9A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3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959"/>
                    </a:solidFill>
                  </a:tcPr>
                </a:tc>
              </a:tr>
              <a:tr h="444382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5G1497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eed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aturation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ik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de-DE" sz="900" b="0" i="0" u="none" strike="noStrike" baseline="30000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/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embrane-anchored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ubiquitin-fold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de-DE" sz="900" b="0" i="0" u="none" strike="noStrike" baseline="30000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92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A0A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35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35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0.81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97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45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747"/>
                    </a:solidFill>
                  </a:tcPr>
                </a:tc>
              </a:tr>
              <a:tr h="31991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1G5200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Mannose-bind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ectin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superfamily protein </a:t>
                      </a:r>
                      <a:r>
                        <a:rPr lang="en-US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92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A0A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4.49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0.67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A9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0.88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8EFF"/>
                    </a:solidFill>
                  </a:tcPr>
                </a:tc>
              </a:tr>
              <a:tr h="317376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4G2803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CN5-related N-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etyltransferas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(GNAT)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amily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de-DE" sz="900" b="0" i="0" u="none" strike="noStrike" baseline="30000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71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24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2.05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D7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666"/>
                    </a:solidFill>
                  </a:tcPr>
                </a:tc>
              </a:tr>
              <a:tr h="322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3G0892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hodanes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like domain-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ntaining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64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2D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4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44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7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E9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F7F"/>
                    </a:solidFill>
                  </a:tcPr>
                </a:tc>
              </a:tr>
              <a:tr h="327530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5G0223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aloacid dehalogenase-like hydrolase family protein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64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2D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2.88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0.85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9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9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3B3FF"/>
                    </a:solidFill>
                  </a:tcPr>
                </a:tc>
              </a:tr>
              <a:tr h="324987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1G8013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etratricopeptide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repeat (TPR)-like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uperfamily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protein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29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5A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2.27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41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B4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1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6AFF"/>
                    </a:solidFill>
                  </a:tcPr>
                </a:tc>
              </a:tr>
              <a:tr h="215764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3G5151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ransmembran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28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C5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77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1D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7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C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9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474"/>
                    </a:solidFill>
                  </a:tcPr>
                </a:tc>
              </a:tr>
              <a:tr h="149018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1G3216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eta-casein (DUF760)</a:t>
                      </a:r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/ Endo/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xonuclease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/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hosphatase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domain-containing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en-US" sz="900" b="0" i="0" u="none" strike="noStrike" baseline="30000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10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7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18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6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D7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6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</a:tr>
              <a:tr h="195438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1G5643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AS4 (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icotianamin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ynthas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)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01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7E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5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37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04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7A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74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222"/>
                    </a:solidFill>
                  </a:tcPr>
                </a:tc>
              </a:tr>
              <a:tr h="192895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2G4446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GLU28 (Beta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lucosidas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)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00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F7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2.2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3.32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58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93265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5G5712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ucleolar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/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iled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body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hosphoprotein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4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B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7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0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6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292"/>
                    </a:solidFill>
                  </a:tcPr>
                </a:tc>
              </a:tr>
              <a:tr h="332589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3G6110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utative endonuclease or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lycosyl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ydrolase</a:t>
                      </a:r>
                      <a:r>
                        <a:rPr lang="en-US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33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65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74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12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7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0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66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CAC"/>
                    </a:solidFill>
                  </a:tcPr>
                </a:tc>
              </a:tr>
              <a:tr h="200506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1G1430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RM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epeat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uperfamily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67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B2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56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93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43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8C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65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DAD"/>
                    </a:solidFill>
                  </a:tcPr>
                </a:tc>
              </a:tr>
              <a:tr h="109348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5G0657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XE15 (Probable carboxylesterase 15)</a:t>
                      </a:r>
                      <a:r>
                        <a:rPr lang="de-DE" sz="900" b="0" i="0" u="none" strike="noStrike" baseline="30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80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91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4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C4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4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4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39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D4DFF"/>
                    </a:solidFill>
                  </a:tcPr>
                </a:tc>
              </a:tr>
              <a:tr h="210660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4G1942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ectinacetylesteras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amily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70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6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87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0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0.8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090FF"/>
                    </a:solidFill>
                  </a:tcPr>
                </a:tc>
              </a:tr>
              <a:tr h="94090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2G47680</a:t>
                      </a: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Zinc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finger (CCCH type)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elicase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amily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28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2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2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A4A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2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2543" marR="2543" marT="254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BEBE"/>
                    </a:solidFill>
                  </a:tcPr>
                </a:tc>
              </a:tr>
            </a:tbl>
          </a:graphicData>
        </a:graphic>
      </p:graphicFrame>
      <p:sp>
        <p:nvSpPr>
          <p:cNvPr id="4" name="Rechteck 3"/>
          <p:cNvSpPr/>
          <p:nvPr/>
        </p:nvSpPr>
        <p:spPr>
          <a:xfrm>
            <a:off x="624840" y="7564216"/>
            <a:ext cx="566166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l Figure 2. Genes in the core module encoding proteins not related to one of the major functional groups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rrangement of micro-array based expression data is as given in Fig. 2. All data represent log2-fold expression changes. Gene identities (Locus) and respective encoded proteins (Description) are given in columns to the left. Genes encoding proteins with predicted or proven plastid localization are high-lighted in light-green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hteck 15"/>
          <p:cNvSpPr/>
          <p:nvPr/>
        </p:nvSpPr>
        <p:spPr>
          <a:xfrm>
            <a:off x="687629" y="3990126"/>
            <a:ext cx="554492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l Figure 3. Genes with opposite expression profiles in the LIN and NF data sets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rrangement of micro-array based expression data is as given in Fig. 2. All data represent log2-fold expression changes. Gene identities (Locus) and respective encoded proteins (Description) are given in columns to the left. Genes encoding proteins with predicted or proven plastid localization are high-lighted in light-green.</a:t>
            </a:r>
          </a:p>
        </p:txBody>
      </p:sp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8424253"/>
              </p:ext>
            </p:extLst>
          </p:nvPr>
        </p:nvGraphicFramePr>
        <p:xfrm>
          <a:off x="769620" y="920328"/>
          <a:ext cx="4932071" cy="2802238"/>
        </p:xfrm>
        <a:graphic>
          <a:graphicData uri="http://schemas.openxmlformats.org/drawingml/2006/table">
            <a:tbl>
              <a:tblPr/>
              <a:tblGrid>
                <a:gridCol w="722738"/>
                <a:gridCol w="2071471"/>
                <a:gridCol w="517867"/>
                <a:gridCol w="538734"/>
                <a:gridCol w="517867"/>
                <a:gridCol w="563394"/>
              </a:tblGrid>
              <a:tr h="193456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IN versus NF </a:t>
                      </a:r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unter-regulation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198292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ocus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escription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T 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IN 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vs. WT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T NF vs. WT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p7-1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vs. WT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T light vs. WT dark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5566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5G23010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AM1 (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ethylthioalkylmalate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  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ynthas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)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2.48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5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6C6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79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B1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88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246656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3G53980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ipid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ransfer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amily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F7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3.32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9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5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4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45FF"/>
                    </a:solidFill>
                  </a:tcPr>
                </a:tc>
              </a:tr>
              <a:tr h="324844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5G37260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VE2 (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eveille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MYB </a:t>
                      </a:r>
                      <a:r>
                        <a:rPr lang="fr-FR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omain</a:t>
                      </a:r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       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fr-FR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)</a:t>
                      </a:r>
                      <a:r>
                        <a:rPr lang="fr-FR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r>
                        <a:rPr lang="fr-FR" sz="900" b="0" i="0" u="none" strike="noStrike" baseline="30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6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C6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13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6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64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F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14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6DFF"/>
                    </a:solidFill>
                  </a:tcPr>
                </a:tc>
              </a:tr>
              <a:tr h="220980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5G37990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IMT1 (SABATH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en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amily</a:t>
                      </a:r>
                      <a:r>
                        <a:rPr lang="de-DE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)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34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55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3.1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3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D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37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</a:tr>
              <a:tr h="312420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1G67860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ipase GDSL domain-containing protein</a:t>
                      </a:r>
                      <a:r>
                        <a:rPr lang="de-DE" sz="900" b="0" i="0" u="none" strike="noStrike" baseline="30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83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61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57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3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7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38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4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44FF"/>
                    </a:solidFill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5G14920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ASA14 (Gibberellin-regulated family protein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4)</a:t>
                      </a:r>
                      <a:r>
                        <a:rPr lang="en-US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94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80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96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404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8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F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22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464FF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2G37870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ipid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ransfer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amily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de-DE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  <a:r>
                        <a:rPr lang="de-DE" sz="900" b="0" i="0" u="none" strike="noStrike" baseline="300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.b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53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2.28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9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5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6D6D"/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T4G35770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EN1 (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enescenc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1)</a:t>
                      </a: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29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1.80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919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72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1" i="0" u="none" strike="noStrike" dirty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de-DE" sz="900" b="1" i="0" u="none" strike="noStrike" dirty="0" smtClean="0">
                          <a:solidFill>
                            <a:srgbClr val="E7E6E6"/>
                          </a:solidFill>
                          <a:latin typeface="Arial" pitchFamily="34" charset="0"/>
                          <a:cs typeface="Arial" pitchFamily="34" charset="0"/>
                        </a:rPr>
                        <a:t>3.37</a:t>
                      </a:r>
                      <a:endParaRPr lang="de-DE" sz="900" b="1" i="0" u="none" strike="noStrike" dirty="0">
                        <a:solidFill>
                          <a:srgbClr val="E7E6E6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4836" marR="4836" marT="483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1</Words>
  <Application>Microsoft Office PowerPoint</Application>
  <PresentationFormat>Bildschirmpräsentation (4:3)</PresentationFormat>
  <Paragraphs>248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6" baseType="lpstr">
      <vt:lpstr>Arial</vt:lpstr>
      <vt:lpstr>Calibri</vt:lpstr>
      <vt:lpstr>Larissa-Desig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Thomas</dc:creator>
  <cp:lastModifiedBy>Kontrolle</cp:lastModifiedBy>
  <cp:revision>79</cp:revision>
  <dcterms:created xsi:type="dcterms:W3CDTF">2018-03-28T17:05:44Z</dcterms:created>
  <dcterms:modified xsi:type="dcterms:W3CDTF">2021-01-26T21:39:36Z</dcterms:modified>
</cp:coreProperties>
</file>